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EF36A-8CD5-4740-A866-43F87D5222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5CC10-6DBB-4184-B722-3BD70A2497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4CA7D-66D2-44CC-A95C-7FA74EB452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94781-9D42-4B09-B84A-C2F4B37544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51E50-F9D8-41FD-9646-25689F50A7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0A054-CC38-4C6A-81DC-3A6DEF83EC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D1444-62E8-4CE2-A041-7D9AE7EE59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90280-3ECC-4D42-8122-60D6CADB5A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D0FEF-EA18-486D-B89B-B6F77FF4C5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D7E72-25FD-461D-A8D9-44BE6238BB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94254-1A50-46B6-B221-85ADCE9A3F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8431D-43FD-4249-B492-2B5A1A99AC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191CB22-50CF-4549-A799-8DE033AEE24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4.png"/><Relationship Id="rId7" Type="http://schemas.openxmlformats.org/officeDocument/2006/relationships/image" Target="../media/image3.png"/><Relationship Id="rId8" Type="http://schemas.openxmlformats.org/officeDocument/2006/relationships/image" Target="../media/image1.png"/><Relationship Id="rId9" Type="http://schemas.openxmlformats.org/officeDocument/2006/relationships/image" Target="../media/image2.png"/><Relationship Id="rId10" Type="http://schemas.openxmlformats.org/officeDocument/2006/relationships/image" Target="../media/image4.png"/><Relationship Id="rId11" Type="http://schemas.openxmlformats.org/officeDocument/2006/relationships/image" Target="../media/image2.png"/><Relationship Id="rId12" Type="http://schemas.openxmlformats.org/officeDocument/2006/relationships/image" Target="../media/image4.png"/><Relationship Id="rId13" Type="http://schemas.openxmlformats.org/officeDocument/2006/relationships/image" Target="../media/image4.png"/><Relationship Id="rId14" Type="http://schemas.openxmlformats.org/officeDocument/2006/relationships/image" Target="../media/image4.png"/><Relationship Id="rId15" Type="http://schemas.openxmlformats.org/officeDocument/2006/relationships/image" Target="../media/image1.png"/><Relationship Id="rId16" Type="http://schemas.openxmlformats.org/officeDocument/2006/relationships/image" Target="../media/image4.png"/><Relationship Id="rId17" Type="http://schemas.openxmlformats.org/officeDocument/2006/relationships/image" Target="../media/image4.png"/><Relationship Id="rId18" Type="http://schemas.openxmlformats.org/officeDocument/2006/relationships/image" Target="../media/image3.png"/><Relationship Id="rId19" Type="http://schemas.openxmlformats.org/officeDocument/2006/relationships/image" Target="../media/image4.png"/><Relationship Id="rId2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1" descr=""/>
          <p:cNvPicPr/>
          <p:nvPr/>
        </p:nvPicPr>
        <p:blipFill>
          <a:blip r:embed="rId1"/>
          <a:stretch/>
        </p:blipFill>
        <p:spPr>
          <a:xfrm>
            <a:off x="4627440" y="3233880"/>
            <a:ext cx="1257480" cy="3711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02" descr=""/>
          <p:cNvPicPr/>
          <p:nvPr/>
        </p:nvPicPr>
        <p:blipFill>
          <a:blip r:embed="rId2"/>
          <a:stretch/>
        </p:blipFill>
        <p:spPr>
          <a:xfrm>
            <a:off x="1152360" y="3273480"/>
            <a:ext cx="1257480" cy="369720"/>
          </a:xfrm>
          <a:prstGeom prst="rect">
            <a:avLst/>
          </a:prstGeom>
          <a:ln w="0">
            <a:noFill/>
          </a:ln>
        </p:spPr>
      </p:pic>
      <p:grpSp>
        <p:nvGrpSpPr>
          <p:cNvPr id="43" name="Teardrop 103"/>
          <p:cNvGrpSpPr/>
          <p:nvPr/>
        </p:nvGrpSpPr>
        <p:grpSpPr>
          <a:xfrm>
            <a:off x="2432160" y="2494080"/>
            <a:ext cx="1085760" cy="657000"/>
            <a:chOff x="2432160" y="2494080"/>
            <a:chExt cx="1085760" cy="657000"/>
          </a:xfrm>
        </p:grpSpPr>
        <p:pic>
          <p:nvPicPr>
            <p:cNvPr id="44" name="Teardrop 103" descr=""/>
            <p:cNvPicPr/>
            <p:nvPr/>
          </p:nvPicPr>
          <p:blipFill>
            <a:blip r:embed="rId3"/>
            <a:stretch/>
          </p:blipFill>
          <p:spPr>
            <a:xfrm>
              <a:off x="2432160" y="2494080"/>
              <a:ext cx="1085760" cy="65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2633760" y="2608200"/>
              <a:ext cx="679320" cy="37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O3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6" name="Teardrop 104"/>
          <p:cNvGrpSpPr/>
          <p:nvPr/>
        </p:nvGrpSpPr>
        <p:grpSpPr>
          <a:xfrm>
            <a:off x="1017720" y="2762280"/>
            <a:ext cx="939600" cy="650880"/>
            <a:chOff x="1017720" y="2762280"/>
            <a:chExt cx="939600" cy="650880"/>
          </a:xfrm>
        </p:grpSpPr>
        <p:pic>
          <p:nvPicPr>
            <p:cNvPr id="47" name="Teardrop 104" descr=""/>
            <p:cNvPicPr/>
            <p:nvPr/>
          </p:nvPicPr>
          <p:blipFill>
            <a:blip r:embed="rId4"/>
            <a:stretch/>
          </p:blipFill>
          <p:spPr>
            <a:xfrm>
              <a:off x="1017720" y="2762280"/>
              <a:ext cx="939600" cy="65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"/>
            <p:cNvSpPr/>
            <p:nvPr/>
          </p:nvSpPr>
          <p:spPr>
            <a:xfrm>
              <a:off x="1201680" y="2874960"/>
              <a:ext cx="576360" cy="37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9" name="Teardrop 105"/>
          <p:cNvGrpSpPr/>
          <p:nvPr/>
        </p:nvGrpSpPr>
        <p:grpSpPr>
          <a:xfrm>
            <a:off x="5297400" y="1981080"/>
            <a:ext cx="938160" cy="658800"/>
            <a:chOff x="5297400" y="1981080"/>
            <a:chExt cx="938160" cy="658800"/>
          </a:xfrm>
        </p:grpSpPr>
        <p:pic>
          <p:nvPicPr>
            <p:cNvPr id="50" name="Teardrop 105" descr=""/>
            <p:cNvPicPr/>
            <p:nvPr/>
          </p:nvPicPr>
          <p:blipFill>
            <a:blip r:embed="rId5"/>
            <a:stretch/>
          </p:blipFill>
          <p:spPr>
            <a:xfrm>
              <a:off x="5297400" y="1981080"/>
              <a:ext cx="93816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5475240" y="2100240"/>
              <a:ext cx="577800" cy="37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" name="TextBox 106"/>
          <p:cNvSpPr/>
          <p:nvPr/>
        </p:nvSpPr>
        <p:spPr>
          <a:xfrm>
            <a:off x="1239120" y="351936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H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" name="Group 107"/>
          <p:cNvGrpSpPr/>
          <p:nvPr/>
        </p:nvGrpSpPr>
        <p:grpSpPr>
          <a:xfrm>
            <a:off x="5519880" y="3086280"/>
            <a:ext cx="431640" cy="268200"/>
            <a:chOff x="5519880" y="3086280"/>
            <a:chExt cx="431640" cy="268200"/>
          </a:xfrm>
        </p:grpSpPr>
        <p:sp>
          <p:nvSpPr>
            <p:cNvPr id="54" name="Straight Connector 108"/>
            <p:cNvSpPr/>
            <p:nvPr/>
          </p:nvSpPr>
          <p:spPr>
            <a:xfrm>
              <a:off x="5519880" y="3086280"/>
              <a:ext cx="43164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109"/>
            <p:cNvSpPr/>
            <p:nvPr/>
          </p:nvSpPr>
          <p:spPr>
            <a:xfrm flipH="1">
              <a:off x="5532480" y="3087720"/>
              <a:ext cx="1440" cy="2667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6" name="Multiply 110"/>
          <p:cNvSpPr/>
          <p:nvPr/>
        </p:nvSpPr>
        <p:spPr>
          <a:xfrm>
            <a:off x="5884920" y="2859120"/>
            <a:ext cx="341280" cy="453960"/>
          </a:xfrm>
          <a:custGeom>
            <a:avLst/>
            <a:gdLst/>
            <a:ahLst/>
            <a:rect l="l" t="t" r="r" b="b"/>
            <a:pathLst>
              <a:path w="341312" h="454025">
                <a:moveTo>
                  <a:pt x="49891" y="133164"/>
                </a:moveTo>
                <a:lnTo>
                  <a:pt x="114058" y="84927"/>
                </a:lnTo>
                <a:lnTo>
                  <a:pt x="170656" y="160215"/>
                </a:lnTo>
                <a:lnTo>
                  <a:pt x="227254" y="84927"/>
                </a:lnTo>
                <a:lnTo>
                  <a:pt x="291421" y="133164"/>
                </a:lnTo>
                <a:lnTo>
                  <a:pt x="220871" y="227013"/>
                </a:lnTo>
                <a:lnTo>
                  <a:pt x="291421" y="320861"/>
                </a:lnTo>
                <a:lnTo>
                  <a:pt x="227254" y="369098"/>
                </a:lnTo>
                <a:lnTo>
                  <a:pt x="170656" y="293810"/>
                </a:lnTo>
                <a:lnTo>
                  <a:pt x="114058" y="369098"/>
                </a:lnTo>
                <a:lnTo>
                  <a:pt x="49891" y="320861"/>
                </a:lnTo>
                <a:lnTo>
                  <a:pt x="120441" y="227013"/>
                </a:lnTo>
                <a:lnTo>
                  <a:pt x="49891" y="133164"/>
                </a:lnTo>
                <a:close/>
              </a:path>
            </a:pathLst>
          </a:custGeom>
          <a:solidFill>
            <a:srgbClr val="c0504d"/>
          </a:solidFill>
          <a:ln w="9360">
            <a:solidFill>
              <a:srgbClr val="c0504d"/>
            </a:solidFill>
            <a:round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" name="Group 111"/>
          <p:cNvGrpSpPr/>
          <p:nvPr/>
        </p:nvGrpSpPr>
        <p:grpSpPr>
          <a:xfrm>
            <a:off x="2060640" y="3100320"/>
            <a:ext cx="431640" cy="268200"/>
            <a:chOff x="2060640" y="3100320"/>
            <a:chExt cx="431640" cy="268200"/>
          </a:xfrm>
        </p:grpSpPr>
        <p:sp>
          <p:nvSpPr>
            <p:cNvPr id="58" name="Straight Connector 112"/>
            <p:cNvSpPr/>
            <p:nvPr/>
          </p:nvSpPr>
          <p:spPr>
            <a:xfrm>
              <a:off x="2060640" y="3100320"/>
              <a:ext cx="43164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Straight Connector 113"/>
            <p:cNvSpPr/>
            <p:nvPr/>
          </p:nvSpPr>
          <p:spPr>
            <a:xfrm flipH="1">
              <a:off x="2073240" y="3101760"/>
              <a:ext cx="1440" cy="2667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TextBox 114"/>
          <p:cNvSpPr/>
          <p:nvPr/>
        </p:nvSpPr>
        <p:spPr>
          <a:xfrm>
            <a:off x="4757040" y="346536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H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15"/>
          <p:cNvSpPr/>
          <p:nvPr/>
        </p:nvSpPr>
        <p:spPr>
          <a:xfrm>
            <a:off x="743040" y="120600"/>
            <a:ext cx="232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rug sensitive cel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16"/>
          <p:cNvSpPr/>
          <p:nvPr/>
        </p:nvSpPr>
        <p:spPr>
          <a:xfrm>
            <a:off x="3942000" y="104760"/>
            <a:ext cx="255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rug Resistance cel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3" name="Teardrop 117"/>
          <p:cNvGrpSpPr/>
          <p:nvPr/>
        </p:nvGrpSpPr>
        <p:grpSpPr>
          <a:xfrm>
            <a:off x="128520" y="5321160"/>
            <a:ext cx="938160" cy="658800"/>
            <a:chOff x="128520" y="5321160"/>
            <a:chExt cx="938160" cy="658800"/>
          </a:xfrm>
        </p:grpSpPr>
        <p:pic>
          <p:nvPicPr>
            <p:cNvPr id="64" name="Teardrop 117" descr=""/>
            <p:cNvPicPr/>
            <p:nvPr/>
          </p:nvPicPr>
          <p:blipFill>
            <a:blip r:embed="rId6"/>
            <a:stretch/>
          </p:blipFill>
          <p:spPr>
            <a:xfrm>
              <a:off x="128520" y="5321160"/>
              <a:ext cx="93816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"/>
            <p:cNvSpPr/>
            <p:nvPr/>
          </p:nvSpPr>
          <p:spPr>
            <a:xfrm>
              <a:off x="309600" y="5440320"/>
              <a:ext cx="576360" cy="37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" name="Teardrop 118"/>
          <p:cNvGrpSpPr/>
          <p:nvPr/>
        </p:nvGrpSpPr>
        <p:grpSpPr>
          <a:xfrm>
            <a:off x="785880" y="4681440"/>
            <a:ext cx="939600" cy="652680"/>
            <a:chOff x="785880" y="4681440"/>
            <a:chExt cx="939600" cy="652680"/>
          </a:xfrm>
        </p:grpSpPr>
        <p:pic>
          <p:nvPicPr>
            <p:cNvPr id="67" name="Teardrop 118" descr=""/>
            <p:cNvPicPr/>
            <p:nvPr/>
          </p:nvPicPr>
          <p:blipFill>
            <a:blip r:embed="rId7"/>
            <a:stretch/>
          </p:blipFill>
          <p:spPr>
            <a:xfrm>
              <a:off x="785880" y="4681440"/>
              <a:ext cx="939600" cy="65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"/>
            <p:cNvSpPr/>
            <p:nvPr/>
          </p:nvSpPr>
          <p:spPr>
            <a:xfrm>
              <a:off x="965160" y="4795920"/>
              <a:ext cx="577800" cy="37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9" name="Picture 119" descr=""/>
          <p:cNvPicPr/>
          <p:nvPr/>
        </p:nvPicPr>
        <p:blipFill>
          <a:blip r:embed="rId8"/>
          <a:stretch/>
        </p:blipFill>
        <p:spPr>
          <a:xfrm>
            <a:off x="1171440" y="6494400"/>
            <a:ext cx="1257480" cy="370080"/>
          </a:xfrm>
          <a:prstGeom prst="rect">
            <a:avLst/>
          </a:prstGeom>
          <a:ln w="0">
            <a:noFill/>
          </a:ln>
        </p:spPr>
      </p:pic>
      <p:grpSp>
        <p:nvGrpSpPr>
          <p:cNvPr id="70" name="Teardrop 120"/>
          <p:cNvGrpSpPr/>
          <p:nvPr/>
        </p:nvGrpSpPr>
        <p:grpSpPr>
          <a:xfrm>
            <a:off x="2451240" y="5711760"/>
            <a:ext cx="1083960" cy="658800"/>
            <a:chOff x="2451240" y="5711760"/>
            <a:chExt cx="1083960" cy="658800"/>
          </a:xfrm>
        </p:grpSpPr>
        <p:pic>
          <p:nvPicPr>
            <p:cNvPr id="71" name="Teardrop 120" descr=""/>
            <p:cNvPicPr/>
            <p:nvPr/>
          </p:nvPicPr>
          <p:blipFill>
            <a:blip r:embed="rId9"/>
            <a:stretch/>
          </p:blipFill>
          <p:spPr>
            <a:xfrm>
              <a:off x="2451240" y="5711760"/>
              <a:ext cx="108396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"/>
            <p:cNvSpPr/>
            <p:nvPr/>
          </p:nvSpPr>
          <p:spPr>
            <a:xfrm>
              <a:off x="2652840" y="5829480"/>
              <a:ext cx="680760" cy="37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O3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3" name="Teardrop 121"/>
          <p:cNvGrpSpPr/>
          <p:nvPr/>
        </p:nvGrpSpPr>
        <p:grpSpPr>
          <a:xfrm>
            <a:off x="1042920" y="5979960"/>
            <a:ext cx="938160" cy="658800"/>
            <a:chOff x="1042920" y="5979960"/>
            <a:chExt cx="938160" cy="658800"/>
          </a:xfrm>
        </p:grpSpPr>
        <p:pic>
          <p:nvPicPr>
            <p:cNvPr id="74" name="Teardrop 121" descr=""/>
            <p:cNvPicPr/>
            <p:nvPr/>
          </p:nvPicPr>
          <p:blipFill>
            <a:blip r:embed="rId10"/>
            <a:stretch/>
          </p:blipFill>
          <p:spPr>
            <a:xfrm>
              <a:off x="1042920" y="5979960"/>
              <a:ext cx="93816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"/>
            <p:cNvSpPr/>
            <p:nvPr/>
          </p:nvSpPr>
          <p:spPr>
            <a:xfrm>
              <a:off x="1222200" y="6095880"/>
              <a:ext cx="576360" cy="37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6" name="TextBox 122"/>
          <p:cNvSpPr/>
          <p:nvPr/>
        </p:nvSpPr>
        <p:spPr>
          <a:xfrm>
            <a:off x="1258920" y="674064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H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" name="Group 123"/>
          <p:cNvGrpSpPr/>
          <p:nvPr/>
        </p:nvGrpSpPr>
        <p:grpSpPr>
          <a:xfrm>
            <a:off x="2081160" y="6319800"/>
            <a:ext cx="430200" cy="270000"/>
            <a:chOff x="2081160" y="6319800"/>
            <a:chExt cx="430200" cy="270000"/>
          </a:xfrm>
        </p:grpSpPr>
        <p:sp>
          <p:nvSpPr>
            <p:cNvPr id="78" name="Straight Connector 124"/>
            <p:cNvSpPr/>
            <p:nvPr/>
          </p:nvSpPr>
          <p:spPr>
            <a:xfrm>
              <a:off x="2081160" y="6319800"/>
              <a:ext cx="43020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Straight Connector 125"/>
            <p:cNvSpPr/>
            <p:nvPr/>
          </p:nvSpPr>
          <p:spPr>
            <a:xfrm flipH="1">
              <a:off x="2093760" y="6321240"/>
              <a:ext cx="1440" cy="268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0" name="Teardrop 126"/>
          <p:cNvGrpSpPr/>
          <p:nvPr/>
        </p:nvGrpSpPr>
        <p:grpSpPr>
          <a:xfrm>
            <a:off x="2620800" y="4943520"/>
            <a:ext cx="1086120" cy="658800"/>
            <a:chOff x="2620800" y="4943520"/>
            <a:chExt cx="1086120" cy="658800"/>
          </a:xfrm>
        </p:grpSpPr>
        <p:pic>
          <p:nvPicPr>
            <p:cNvPr id="81" name="Teardrop 126" descr=""/>
            <p:cNvPicPr/>
            <p:nvPr/>
          </p:nvPicPr>
          <p:blipFill>
            <a:blip r:embed="rId11"/>
            <a:stretch/>
          </p:blipFill>
          <p:spPr>
            <a:xfrm>
              <a:off x="2620800" y="4943520"/>
              <a:ext cx="108612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"/>
            <p:cNvSpPr/>
            <p:nvPr/>
          </p:nvSpPr>
          <p:spPr>
            <a:xfrm>
              <a:off x="2822400" y="5062680"/>
              <a:ext cx="681120" cy="37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O3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3" name="Teardrop 127"/>
          <p:cNvGrpSpPr/>
          <p:nvPr/>
        </p:nvGrpSpPr>
        <p:grpSpPr>
          <a:xfrm>
            <a:off x="4286160" y="1420920"/>
            <a:ext cx="938160" cy="657000"/>
            <a:chOff x="4286160" y="1420920"/>
            <a:chExt cx="938160" cy="657000"/>
          </a:xfrm>
        </p:grpSpPr>
        <p:pic>
          <p:nvPicPr>
            <p:cNvPr id="84" name="Teardrop 127" descr=""/>
            <p:cNvPicPr/>
            <p:nvPr/>
          </p:nvPicPr>
          <p:blipFill>
            <a:blip r:embed="rId12"/>
            <a:stretch/>
          </p:blipFill>
          <p:spPr>
            <a:xfrm>
              <a:off x="4286160" y="1420920"/>
              <a:ext cx="938160" cy="65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"/>
            <p:cNvSpPr/>
            <p:nvPr/>
          </p:nvSpPr>
          <p:spPr>
            <a:xfrm>
              <a:off x="4464000" y="1536840"/>
              <a:ext cx="576360" cy="37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6" name="Teardrop 128"/>
          <p:cNvGrpSpPr/>
          <p:nvPr/>
        </p:nvGrpSpPr>
        <p:grpSpPr>
          <a:xfrm>
            <a:off x="5095800" y="1103400"/>
            <a:ext cx="939960" cy="658800"/>
            <a:chOff x="5095800" y="1103400"/>
            <a:chExt cx="939960" cy="658800"/>
          </a:xfrm>
        </p:grpSpPr>
        <p:pic>
          <p:nvPicPr>
            <p:cNvPr id="87" name="Teardrop 128" descr=""/>
            <p:cNvPicPr/>
            <p:nvPr/>
          </p:nvPicPr>
          <p:blipFill>
            <a:blip r:embed="rId13"/>
            <a:stretch/>
          </p:blipFill>
          <p:spPr>
            <a:xfrm>
              <a:off x="5095800" y="1103400"/>
              <a:ext cx="93996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"/>
            <p:cNvSpPr/>
            <p:nvPr/>
          </p:nvSpPr>
          <p:spPr>
            <a:xfrm>
              <a:off x="5280120" y="1220760"/>
              <a:ext cx="576000" cy="37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9" name="Teardrop 129"/>
          <p:cNvGrpSpPr/>
          <p:nvPr/>
        </p:nvGrpSpPr>
        <p:grpSpPr>
          <a:xfrm>
            <a:off x="4286160" y="1951200"/>
            <a:ext cx="938160" cy="658800"/>
            <a:chOff x="4286160" y="1951200"/>
            <a:chExt cx="938160" cy="658800"/>
          </a:xfrm>
        </p:grpSpPr>
        <p:pic>
          <p:nvPicPr>
            <p:cNvPr id="90" name="Teardrop 129" descr=""/>
            <p:cNvPicPr/>
            <p:nvPr/>
          </p:nvPicPr>
          <p:blipFill>
            <a:blip r:embed="rId14"/>
            <a:stretch/>
          </p:blipFill>
          <p:spPr>
            <a:xfrm>
              <a:off x="4286160" y="1951200"/>
              <a:ext cx="93816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"/>
            <p:cNvSpPr/>
            <p:nvPr/>
          </p:nvSpPr>
          <p:spPr>
            <a:xfrm>
              <a:off x="4464000" y="2070000"/>
              <a:ext cx="576360" cy="37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92" name="Picture 130" descr=""/>
          <p:cNvPicPr/>
          <p:nvPr/>
        </p:nvPicPr>
        <p:blipFill>
          <a:blip r:embed="rId15"/>
          <a:stretch/>
        </p:blipFill>
        <p:spPr>
          <a:xfrm>
            <a:off x="4765680" y="6608880"/>
            <a:ext cx="1257120" cy="371520"/>
          </a:xfrm>
          <a:prstGeom prst="rect">
            <a:avLst/>
          </a:prstGeom>
          <a:ln w="0">
            <a:noFill/>
          </a:ln>
        </p:spPr>
      </p:pic>
      <p:grpSp>
        <p:nvGrpSpPr>
          <p:cNvPr id="93" name="Teardrop 131"/>
          <p:cNvGrpSpPr/>
          <p:nvPr/>
        </p:nvGrpSpPr>
        <p:grpSpPr>
          <a:xfrm>
            <a:off x="5430960" y="5194440"/>
            <a:ext cx="939600" cy="657000"/>
            <a:chOff x="5430960" y="5194440"/>
            <a:chExt cx="939600" cy="657000"/>
          </a:xfrm>
        </p:grpSpPr>
        <p:pic>
          <p:nvPicPr>
            <p:cNvPr id="94" name="Teardrop 131" descr=""/>
            <p:cNvPicPr/>
            <p:nvPr/>
          </p:nvPicPr>
          <p:blipFill>
            <a:blip r:embed="rId16"/>
            <a:stretch/>
          </p:blipFill>
          <p:spPr>
            <a:xfrm>
              <a:off x="5430960" y="5194440"/>
              <a:ext cx="939600" cy="65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"/>
            <p:cNvSpPr/>
            <p:nvPr/>
          </p:nvSpPr>
          <p:spPr>
            <a:xfrm>
              <a:off x="5613480" y="5310360"/>
              <a:ext cx="577800" cy="37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6" name="Group 132"/>
          <p:cNvGrpSpPr/>
          <p:nvPr/>
        </p:nvGrpSpPr>
        <p:grpSpPr>
          <a:xfrm>
            <a:off x="5657760" y="6461280"/>
            <a:ext cx="432000" cy="269640"/>
            <a:chOff x="5657760" y="6461280"/>
            <a:chExt cx="432000" cy="269640"/>
          </a:xfrm>
        </p:grpSpPr>
        <p:sp>
          <p:nvSpPr>
            <p:cNvPr id="97" name="Straight Connector 133"/>
            <p:cNvSpPr/>
            <p:nvPr/>
          </p:nvSpPr>
          <p:spPr>
            <a:xfrm>
              <a:off x="5657760" y="6461280"/>
              <a:ext cx="43200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Straight Connector 134"/>
            <p:cNvSpPr/>
            <p:nvPr/>
          </p:nvSpPr>
          <p:spPr>
            <a:xfrm flipH="1">
              <a:off x="5670360" y="6462720"/>
              <a:ext cx="1440" cy="268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9" name="Multiply 135"/>
          <p:cNvSpPr/>
          <p:nvPr/>
        </p:nvSpPr>
        <p:spPr>
          <a:xfrm>
            <a:off x="6022800" y="6234120"/>
            <a:ext cx="339840" cy="453960"/>
          </a:xfrm>
          <a:custGeom>
            <a:avLst/>
            <a:gdLst/>
            <a:ahLst/>
            <a:rect l="l" t="t" r="r" b="b"/>
            <a:pathLst>
              <a:path w="339725" h="454025">
                <a:moveTo>
                  <a:pt x="49605" y="132981"/>
                </a:moveTo>
                <a:lnTo>
                  <a:pt x="113582" y="85110"/>
                </a:lnTo>
                <a:lnTo>
                  <a:pt x="169863" y="160327"/>
                </a:lnTo>
                <a:lnTo>
                  <a:pt x="226143" y="85110"/>
                </a:lnTo>
                <a:lnTo>
                  <a:pt x="290120" y="132981"/>
                </a:lnTo>
                <a:lnTo>
                  <a:pt x="219760" y="227013"/>
                </a:lnTo>
                <a:lnTo>
                  <a:pt x="290120" y="321044"/>
                </a:lnTo>
                <a:lnTo>
                  <a:pt x="226143" y="368915"/>
                </a:lnTo>
                <a:lnTo>
                  <a:pt x="169863" y="293698"/>
                </a:lnTo>
                <a:lnTo>
                  <a:pt x="113582" y="368915"/>
                </a:lnTo>
                <a:lnTo>
                  <a:pt x="49605" y="321044"/>
                </a:lnTo>
                <a:lnTo>
                  <a:pt x="119965" y="227013"/>
                </a:lnTo>
                <a:lnTo>
                  <a:pt x="49605" y="132981"/>
                </a:lnTo>
                <a:close/>
              </a:path>
            </a:pathLst>
          </a:custGeom>
          <a:solidFill>
            <a:srgbClr val="c0504d"/>
          </a:solidFill>
          <a:ln w="9360">
            <a:solidFill>
              <a:srgbClr val="c0504d"/>
            </a:solidFill>
            <a:round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136"/>
          <p:cNvSpPr/>
          <p:nvPr/>
        </p:nvSpPr>
        <p:spPr>
          <a:xfrm>
            <a:off x="4894920" y="684216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H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1" name="Teardrop 137"/>
          <p:cNvGrpSpPr/>
          <p:nvPr/>
        </p:nvGrpSpPr>
        <p:grpSpPr>
          <a:xfrm>
            <a:off x="4419720" y="4694400"/>
            <a:ext cx="938160" cy="658800"/>
            <a:chOff x="4419720" y="4694400"/>
            <a:chExt cx="938160" cy="658800"/>
          </a:xfrm>
        </p:grpSpPr>
        <p:pic>
          <p:nvPicPr>
            <p:cNvPr id="102" name="Teardrop 137" descr=""/>
            <p:cNvPicPr/>
            <p:nvPr/>
          </p:nvPicPr>
          <p:blipFill>
            <a:blip r:embed="rId17"/>
            <a:stretch/>
          </p:blipFill>
          <p:spPr>
            <a:xfrm>
              <a:off x="4419720" y="4694400"/>
              <a:ext cx="93816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3" name=""/>
            <p:cNvSpPr/>
            <p:nvPr/>
          </p:nvSpPr>
          <p:spPr>
            <a:xfrm>
              <a:off x="4602240" y="4813200"/>
              <a:ext cx="576360" cy="37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4" name="Teardrop 138"/>
          <p:cNvGrpSpPr/>
          <p:nvPr/>
        </p:nvGrpSpPr>
        <p:grpSpPr>
          <a:xfrm>
            <a:off x="5237280" y="4316400"/>
            <a:ext cx="938160" cy="652320"/>
            <a:chOff x="5237280" y="4316400"/>
            <a:chExt cx="938160" cy="652320"/>
          </a:xfrm>
        </p:grpSpPr>
        <p:pic>
          <p:nvPicPr>
            <p:cNvPr id="105" name="Teardrop 138" descr=""/>
            <p:cNvPicPr/>
            <p:nvPr/>
          </p:nvPicPr>
          <p:blipFill>
            <a:blip r:embed="rId18"/>
            <a:stretch/>
          </p:blipFill>
          <p:spPr>
            <a:xfrm>
              <a:off x="5237280" y="4316400"/>
              <a:ext cx="938160" cy="652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"/>
            <p:cNvSpPr/>
            <p:nvPr/>
          </p:nvSpPr>
          <p:spPr>
            <a:xfrm>
              <a:off x="5418000" y="4430880"/>
              <a:ext cx="576360" cy="37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7" name="Teardrop 139"/>
          <p:cNvGrpSpPr/>
          <p:nvPr/>
        </p:nvGrpSpPr>
        <p:grpSpPr>
          <a:xfrm>
            <a:off x="4419720" y="5230800"/>
            <a:ext cx="938160" cy="657360"/>
            <a:chOff x="4419720" y="5230800"/>
            <a:chExt cx="938160" cy="657360"/>
          </a:xfrm>
        </p:grpSpPr>
        <p:pic>
          <p:nvPicPr>
            <p:cNvPr id="108" name="Teardrop 139" descr=""/>
            <p:cNvPicPr/>
            <p:nvPr/>
          </p:nvPicPr>
          <p:blipFill>
            <a:blip r:embed="rId19"/>
            <a:stretch/>
          </p:blipFill>
          <p:spPr>
            <a:xfrm>
              <a:off x="4419720" y="5230800"/>
              <a:ext cx="938160" cy="657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"/>
            <p:cNvSpPr/>
            <p:nvPr/>
          </p:nvSpPr>
          <p:spPr>
            <a:xfrm>
              <a:off x="4602240" y="5346720"/>
              <a:ext cx="576360" cy="37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K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10" name="Straight Arrow Connector 140"/>
          <p:cNvCxnSpPr/>
          <p:nvPr/>
        </p:nvCxnSpPr>
        <p:spPr>
          <a:xfrm>
            <a:off x="1152000" y="5311800"/>
            <a:ext cx="273960" cy="534240"/>
          </a:xfrm>
          <a:prstGeom prst="straightConnector1">
            <a:avLst/>
          </a:prstGeom>
          <a:ln w="25560">
            <a:solidFill>
              <a:srgbClr val="4f81bd"/>
            </a:solidFill>
            <a:prstDash val="dash"/>
            <a:miter/>
            <a:tailEnd len="med" type="arrow" w="med"/>
          </a:ln>
        </p:spPr>
      </p:cxnSp>
      <p:cxnSp>
        <p:nvCxnSpPr>
          <p:cNvPr id="111" name="Straight Arrow Connector 141"/>
          <p:cNvCxnSpPr/>
          <p:nvPr/>
        </p:nvCxnSpPr>
        <p:spPr>
          <a:xfrm>
            <a:off x="750600" y="6075000"/>
            <a:ext cx="275400" cy="446760"/>
          </a:xfrm>
          <a:prstGeom prst="straightConnector1">
            <a:avLst/>
          </a:prstGeom>
          <a:ln w="25560">
            <a:solidFill>
              <a:srgbClr val="4f81bd"/>
            </a:solidFill>
            <a:prstDash val="dash"/>
            <a:miter/>
            <a:tailEnd len="med" type="arrow" w="med"/>
          </a:ln>
        </p:spPr>
      </p:cxnSp>
      <p:cxnSp>
        <p:nvCxnSpPr>
          <p:cNvPr id="112" name="Straight Arrow Connector 142"/>
          <p:cNvCxnSpPr/>
          <p:nvPr/>
        </p:nvCxnSpPr>
        <p:spPr>
          <a:xfrm>
            <a:off x="4854600" y="2700360"/>
            <a:ext cx="273240" cy="534240"/>
          </a:xfrm>
          <a:prstGeom prst="straightConnector1">
            <a:avLst/>
          </a:prstGeom>
          <a:ln w="25560">
            <a:solidFill>
              <a:srgbClr val="4f81bd"/>
            </a:solidFill>
            <a:prstDash val="dash"/>
            <a:miter/>
            <a:tailEnd len="med" type="arrow" w="med"/>
          </a:ln>
        </p:spPr>
      </p:cxnSp>
      <p:cxnSp>
        <p:nvCxnSpPr>
          <p:cNvPr id="113" name="Straight Arrow Connector 143"/>
          <p:cNvCxnSpPr/>
          <p:nvPr/>
        </p:nvCxnSpPr>
        <p:spPr>
          <a:xfrm>
            <a:off x="4890600" y="5987880"/>
            <a:ext cx="273960" cy="534240"/>
          </a:xfrm>
          <a:prstGeom prst="straightConnector1">
            <a:avLst/>
          </a:prstGeom>
          <a:ln w="25560">
            <a:solidFill>
              <a:srgbClr val="4f81bd"/>
            </a:solidFill>
            <a:prstDash val="dash"/>
            <a:miter/>
            <a:tailEnd len="med" type="arrow" w="med"/>
          </a:ln>
        </p:spPr>
      </p:cxnSp>
      <p:sp>
        <p:nvSpPr>
          <p:cNvPr id="114" name="Down Arrow 144"/>
          <p:cNvSpPr/>
          <p:nvPr/>
        </p:nvSpPr>
        <p:spPr>
          <a:xfrm>
            <a:off x="3376440" y="3605040"/>
            <a:ext cx="412920" cy="906480"/>
          </a:xfrm>
          <a:prstGeom prst="downArrow">
            <a:avLst>
              <a:gd name="adj1" fmla="val 50000"/>
              <a:gd name="adj2" fmla="val 49984"/>
            </a:avLst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145"/>
          <p:cNvSpPr/>
          <p:nvPr/>
        </p:nvSpPr>
        <p:spPr>
          <a:xfrm>
            <a:off x="3776760" y="3776760"/>
            <a:ext cx="94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aclitax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146"/>
          <p:cNvSpPr/>
          <p:nvPr/>
        </p:nvSpPr>
        <p:spPr>
          <a:xfrm>
            <a:off x="3796920" y="4008600"/>
            <a:ext cx="96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pirubic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147"/>
          <p:cNvSpPr/>
          <p:nvPr/>
        </p:nvSpPr>
        <p:spPr>
          <a:xfrm>
            <a:off x="4824720" y="272556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Arial"/>
                <a:ea typeface="Arial"/>
              </a:rPr>
              <a:t>X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148"/>
          <p:cNvSpPr/>
          <p:nvPr/>
        </p:nvSpPr>
        <p:spPr>
          <a:xfrm>
            <a:off x="4824720" y="609444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Arial"/>
                <a:ea typeface="Arial"/>
              </a:rPr>
              <a:t>X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149"/>
          <p:cNvSpPr/>
          <p:nvPr/>
        </p:nvSpPr>
        <p:spPr>
          <a:xfrm>
            <a:off x="2436480" y="3311640"/>
            <a:ext cx="88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O3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150"/>
          <p:cNvSpPr/>
          <p:nvPr/>
        </p:nvSpPr>
        <p:spPr>
          <a:xfrm>
            <a:off x="2485440" y="6537240"/>
            <a:ext cx="88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O3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151"/>
          <p:cNvSpPr/>
          <p:nvPr/>
        </p:nvSpPr>
        <p:spPr>
          <a:xfrm>
            <a:off x="6059160" y="6613560"/>
            <a:ext cx="88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O3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152"/>
          <p:cNvSpPr/>
          <p:nvPr/>
        </p:nvSpPr>
        <p:spPr>
          <a:xfrm>
            <a:off x="5930280" y="3222720"/>
            <a:ext cx="88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O3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16"/>
          <p:cNvSpPr/>
          <p:nvPr/>
        </p:nvSpPr>
        <p:spPr>
          <a:xfrm>
            <a:off x="4827960" y="9618840"/>
            <a:ext cx="200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05T23:45:37Z</dcterms:created>
  <dc:creator>Eric Lam</dc:creator>
  <dc:description/>
  <dc:language>en-US</dc:language>
  <cp:lastModifiedBy>Eric Lam</cp:lastModifiedBy>
  <dcterms:modified xsi:type="dcterms:W3CDTF">2015-07-22T15:46:16Z</dcterms:modified>
  <cp:revision>20</cp:revision>
  <dc:subject/>
  <dc:title>Slide 1</dc:title>
</cp:coreProperties>
</file>